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7" r:id="rId5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4" d="100"/>
          <a:sy n="74" d="100"/>
        </p:scale>
        <p:origin x="450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IN"/>
              <a:t>Sub-cellular</a:t>
            </a:r>
            <a:r>
              <a:rPr lang="en-IN" baseline="0"/>
              <a:t> localization of </a:t>
            </a:r>
            <a:r>
              <a:rPr lang="en-IN" i="1" baseline="0"/>
              <a:t>OrBTB </a:t>
            </a:r>
            <a:r>
              <a:rPr lang="en-IN" baseline="0"/>
              <a:t>genes</a:t>
            </a:r>
            <a:endParaRPr lang="en-IN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9.6526011171680456E-2"/>
          <c:y val="2.4977351910138109E-2"/>
          <c:w val="0.879969715324046"/>
          <c:h val="0.7258378002886064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D$1:$D$6</c:f>
              <c:strCache>
                <c:ptCount val="6"/>
                <c:pt idx="0">
                  <c:v>Extracellular</c:v>
                </c:pt>
                <c:pt idx="1">
                  <c:v>Mitochondrial</c:v>
                </c:pt>
                <c:pt idx="2">
                  <c:v>PlasmaMembrane</c:v>
                </c:pt>
                <c:pt idx="3">
                  <c:v>Nuclear</c:v>
                </c:pt>
                <c:pt idx="4">
                  <c:v>Chloroplast</c:v>
                </c:pt>
                <c:pt idx="5">
                  <c:v>Cytoplasmic</c:v>
                </c:pt>
              </c:strCache>
            </c:strRef>
          </c:cat>
          <c:val>
            <c:numRef>
              <c:f>Sheet1!$E$1:$E$6</c:f>
              <c:numCache>
                <c:formatCode>General</c:formatCode>
                <c:ptCount val="6"/>
                <c:pt idx="0">
                  <c:v>3</c:v>
                </c:pt>
                <c:pt idx="1">
                  <c:v>8</c:v>
                </c:pt>
                <c:pt idx="2">
                  <c:v>17</c:v>
                </c:pt>
                <c:pt idx="3">
                  <c:v>23</c:v>
                </c:pt>
                <c:pt idx="4">
                  <c:v>29</c:v>
                </c:pt>
                <c:pt idx="5">
                  <c:v>3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588-4838-B73E-9EBEDA3FA21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070823280"/>
        <c:axId val="2073616960"/>
      </c:barChart>
      <c:catAx>
        <c:axId val="20708232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73616960"/>
        <c:crosses val="autoZero"/>
        <c:auto val="1"/>
        <c:lblAlgn val="ctr"/>
        <c:lblOffset val="100"/>
        <c:noMultiLvlLbl val="0"/>
      </c:catAx>
      <c:valAx>
        <c:axId val="207361696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Number</a:t>
                </a:r>
                <a:r>
                  <a:rPr lang="en-US" baseline="0"/>
                  <a:t>  of OrBTB genes</a:t>
                </a:r>
                <a:endParaRPr lang="en-US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708232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solidFill>
        <a:schemeClr val="accent1"/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69035-CB9C-41AC-BFD9-57F08FD559BC}" type="datetimeFigureOut">
              <a:rPr lang="en-US" smtClean="0"/>
              <a:t>7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E6189-A79A-4C13-8EE6-738100546C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62295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69035-CB9C-41AC-BFD9-57F08FD559BC}" type="datetimeFigureOut">
              <a:rPr lang="en-US" smtClean="0"/>
              <a:t>7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E6189-A79A-4C13-8EE6-738100546C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78792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69035-CB9C-41AC-BFD9-57F08FD559BC}" type="datetimeFigureOut">
              <a:rPr lang="en-US" smtClean="0"/>
              <a:t>7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E6189-A79A-4C13-8EE6-738100546C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39217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69035-CB9C-41AC-BFD9-57F08FD559BC}" type="datetimeFigureOut">
              <a:rPr lang="en-US" smtClean="0"/>
              <a:t>7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E6189-A79A-4C13-8EE6-738100546C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10601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69035-CB9C-41AC-BFD9-57F08FD559BC}" type="datetimeFigureOut">
              <a:rPr lang="en-US" smtClean="0"/>
              <a:t>7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E6189-A79A-4C13-8EE6-738100546C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63645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69035-CB9C-41AC-BFD9-57F08FD559BC}" type="datetimeFigureOut">
              <a:rPr lang="en-US" smtClean="0"/>
              <a:t>7/1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E6189-A79A-4C13-8EE6-738100546C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27241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69035-CB9C-41AC-BFD9-57F08FD559BC}" type="datetimeFigureOut">
              <a:rPr lang="en-US" smtClean="0"/>
              <a:t>7/11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E6189-A79A-4C13-8EE6-738100546C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49409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69035-CB9C-41AC-BFD9-57F08FD559BC}" type="datetimeFigureOut">
              <a:rPr lang="en-US" smtClean="0"/>
              <a:t>7/11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E6189-A79A-4C13-8EE6-738100546C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17101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69035-CB9C-41AC-BFD9-57F08FD559BC}" type="datetimeFigureOut">
              <a:rPr lang="en-US" smtClean="0"/>
              <a:t>7/11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E6189-A79A-4C13-8EE6-738100546C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49452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69035-CB9C-41AC-BFD9-57F08FD559BC}" type="datetimeFigureOut">
              <a:rPr lang="en-US" smtClean="0"/>
              <a:t>7/1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E6189-A79A-4C13-8EE6-738100546C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33949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E69035-CB9C-41AC-BFD9-57F08FD559BC}" type="datetimeFigureOut">
              <a:rPr lang="en-US" smtClean="0"/>
              <a:t>7/1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E6189-A79A-4C13-8EE6-738100546C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51689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E69035-CB9C-41AC-BFD9-57F08FD559BC}" type="datetimeFigureOut">
              <a:rPr lang="en-US" smtClean="0"/>
              <a:t>7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EE6189-A79A-4C13-8EE6-738100546C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67076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685AC90F-F4EA-4A11-A0B9-1A0C0AFB436C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092071513"/>
              </p:ext>
            </p:extLst>
          </p:nvPr>
        </p:nvGraphicFramePr>
        <p:xfrm>
          <a:off x="529389" y="1941095"/>
          <a:ext cx="5839326" cy="28715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F980AE08-49E0-45B1-AB35-1CF0BA783CF4}"/>
              </a:ext>
            </a:extLst>
          </p:cNvPr>
          <p:cNvSpPr txBox="1"/>
          <p:nvPr/>
        </p:nvSpPr>
        <p:spPr>
          <a:xfrm>
            <a:off x="401053" y="5887453"/>
            <a:ext cx="6176211" cy="49904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1778"/>
              </a:spcAft>
            </a:pPr>
            <a:r>
              <a:rPr lang="en-GB" sz="12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1</a:t>
            </a:r>
            <a:r>
              <a:rPr lang="en-GB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Sub-cellular localization of the BTB/POZ genes in the </a:t>
            </a:r>
            <a:r>
              <a:rPr lang="en-GB" sz="1200" i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ryza rufipogon</a:t>
            </a:r>
            <a:r>
              <a:rPr lang="en-GB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genome</a:t>
            </a:r>
            <a:endParaRPr lang="en-US" sz="12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767519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5418651c-0681-43d7-868b-1c90920dbb03" xsi:nil="true"/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64CF1D3472D484F8E3C8E423AA3B556" ma:contentTypeVersion="12" ma:contentTypeDescription="Create a new document." ma:contentTypeScope="" ma:versionID="a39ac3f3581b14c11d87d381711ebb43">
  <xsd:schema xmlns:xsd="http://www.w3.org/2001/XMLSchema" xmlns:xs="http://www.w3.org/2001/XMLSchema" xmlns:p="http://schemas.microsoft.com/office/2006/metadata/properties" xmlns:ns3="5418651c-0681-43d7-868b-1c90920dbb03" targetNamespace="http://schemas.microsoft.com/office/2006/metadata/properties" ma:root="true" ma:fieldsID="aef970670382c4a46f94ff6e8d109c12" ns3:_="">
    <xsd:import namespace="5418651c-0681-43d7-868b-1c90920dbb03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  <xsd:element ref="ns3:MediaServiceDateTaken" minOccurs="0"/>
                <xsd:element ref="ns3:MediaLengthInSeconds" minOccurs="0"/>
                <xsd:element ref="ns3:MediaServiceLocation" minOccurs="0"/>
                <xsd:element ref="ns3:_activity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418651c-0681-43d7-868b-1c90920dbb03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4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5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7" nillable="true" ma:displayName="MediaLengthInSeconds" ma:hidden="true" ma:internalName="MediaLengthInSeconds" ma:readOnly="true">
      <xsd:simpleType>
        <xsd:restriction base="dms:Unknown"/>
      </xsd:simpleType>
    </xsd:element>
    <xsd:element name="MediaServiceLocation" ma:index="18" nillable="true" ma:displayName="Location" ma:internalName="MediaServiceLocation" ma:readOnly="true">
      <xsd:simpleType>
        <xsd:restriction base="dms:Text"/>
      </xsd:simpleType>
    </xsd:element>
    <xsd:element name="_activity" ma:index="19" nillable="true" ma:displayName="_activity" ma:hidden="true" ma:internalName="_activity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81677962-660B-4945-A911-F8E6D9702022}">
  <ds:schemaRefs>
    <ds:schemaRef ds:uri="5418651c-0681-43d7-868b-1c90920dbb03"/>
    <ds:schemaRef ds:uri="http://purl.org/dc/terms/"/>
    <ds:schemaRef ds:uri="http://schemas.microsoft.com/office/2006/metadata/properties"/>
    <ds:schemaRef ds:uri="http://schemas.microsoft.com/office/infopath/2007/PartnerControls"/>
    <ds:schemaRef ds:uri="http://schemas.microsoft.com/office/2006/documentManagement/types"/>
    <ds:schemaRef ds:uri="http://purl.org/dc/dcmitype/"/>
    <ds:schemaRef ds:uri="http://schemas.openxmlformats.org/package/2006/metadata/core-properties"/>
    <ds:schemaRef ds:uri="http://www.w3.org/XML/1998/namespace"/>
    <ds:schemaRef ds:uri="http://purl.org/dc/elements/1.1/"/>
  </ds:schemaRefs>
</ds:datastoreItem>
</file>

<file path=customXml/itemProps2.xml><?xml version="1.0" encoding="utf-8"?>
<ds:datastoreItem xmlns:ds="http://schemas.openxmlformats.org/officeDocument/2006/customXml" ds:itemID="{64706B27-EC94-4120-BCFE-4B99190F3DBF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A9E5EB9F-990A-4AEA-A550-A73762C84D10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5418651c-0681-43d7-868b-1c90920dbb03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3</TotalTime>
  <Words>26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ndal, Swarupa</dc:creator>
  <cp:lastModifiedBy>Reyes, Benildo</cp:lastModifiedBy>
  <cp:revision>4</cp:revision>
  <dcterms:created xsi:type="dcterms:W3CDTF">2022-04-21T14:54:20Z</dcterms:created>
  <dcterms:modified xsi:type="dcterms:W3CDTF">2023-07-11T14:27:2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64CF1D3472D484F8E3C8E423AA3B556</vt:lpwstr>
  </property>
</Properties>
</file>